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8229600" cy="17830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30" autoAdjust="0"/>
    <p:restoredTop sz="94660"/>
  </p:normalViewPr>
  <p:slideViewPr>
    <p:cSldViewPr snapToGrid="0">
      <p:cViewPr varScale="1">
        <p:scale>
          <a:sx n="49" d="100"/>
          <a:sy n="49" d="100"/>
        </p:scale>
        <p:origin x="27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918144"/>
            <a:ext cx="6995160" cy="620776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9365299"/>
            <a:ext cx="6172200" cy="4304981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668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331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949325"/>
            <a:ext cx="1774508" cy="151107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949325"/>
            <a:ext cx="5220653" cy="151107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947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453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4445323"/>
            <a:ext cx="7098030" cy="7417116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11932608"/>
            <a:ext cx="7098030" cy="3900486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13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4746625"/>
            <a:ext cx="3497580" cy="113134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4746625"/>
            <a:ext cx="3497580" cy="113134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169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949329"/>
            <a:ext cx="7098030" cy="34464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4371024"/>
            <a:ext cx="3481506" cy="21421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6513195"/>
            <a:ext cx="3481506" cy="95799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4371024"/>
            <a:ext cx="3498652" cy="2142171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6513195"/>
            <a:ext cx="3498652" cy="95799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46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971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517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1188720"/>
            <a:ext cx="2654260" cy="4160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2567309"/>
            <a:ext cx="4166235" cy="12671425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5349240"/>
            <a:ext cx="2654260" cy="9910129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273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1188720"/>
            <a:ext cx="2654260" cy="4160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2567309"/>
            <a:ext cx="4166235" cy="12671425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5349240"/>
            <a:ext cx="2654260" cy="9910129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315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949329"/>
            <a:ext cx="7098030" cy="34464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4746625"/>
            <a:ext cx="7098030" cy="113134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6526514"/>
            <a:ext cx="185166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FD1D1-D35C-4926-A790-B4696D97D457}" type="datetimeFigureOut">
              <a:rPr lang="en-US" smtClean="0"/>
              <a:t>5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6526514"/>
            <a:ext cx="277749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6526514"/>
            <a:ext cx="1851660" cy="94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E528C-1FEC-4CF1-BBE7-23A2D026A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831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TextBox 194"/>
          <p:cNvSpPr txBox="1"/>
          <p:nvPr/>
        </p:nvSpPr>
        <p:spPr>
          <a:xfrm>
            <a:off x="0" y="211987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3882992" y="211987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3636232" y="-45893"/>
            <a:ext cx="77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nus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3636232" y="12584659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ecie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240244" y="9724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064" y="489753"/>
            <a:ext cx="3895344" cy="180273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8034" y="502253"/>
            <a:ext cx="3895344" cy="180273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064" y="2481003"/>
            <a:ext cx="3895344" cy="180273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4902" y="2453600"/>
            <a:ext cx="3895344" cy="183053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4064" y="4457101"/>
            <a:ext cx="3895344" cy="183450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94902" y="4482709"/>
            <a:ext cx="3895344" cy="180273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3137" y="6507750"/>
            <a:ext cx="3895344" cy="180670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96996" y="6506855"/>
            <a:ext cx="3895344" cy="180273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7678" y="8523902"/>
            <a:ext cx="3895344" cy="184244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29984" y="8559909"/>
            <a:ext cx="3895344" cy="180273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9220" y="10707254"/>
            <a:ext cx="3895344" cy="180273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89427" y="10707254"/>
            <a:ext cx="3895344" cy="1802738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5799" y="13315207"/>
            <a:ext cx="3895344" cy="181703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89427" y="13316759"/>
            <a:ext cx="3895344" cy="181703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75799" y="15811818"/>
            <a:ext cx="3895344" cy="184870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288184" y="15823694"/>
            <a:ext cx="3895344" cy="1836829"/>
          </a:xfrm>
          <a:prstGeom prst="rect">
            <a:avLst/>
          </a:prstGeom>
        </p:spPr>
      </p:pic>
      <p:sp>
        <p:nvSpPr>
          <p:cNvPr id="203" name="TextBox 202"/>
          <p:cNvSpPr txBox="1"/>
          <p:nvPr/>
        </p:nvSpPr>
        <p:spPr>
          <a:xfrm>
            <a:off x="1766034" y="443237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243" name="TextBox 242"/>
          <p:cNvSpPr txBox="1"/>
          <p:nvPr/>
        </p:nvSpPr>
        <p:spPr>
          <a:xfrm>
            <a:off x="5673978" y="439957"/>
            <a:ext cx="1289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Enterococcus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820125" y="2537236"/>
            <a:ext cx="1358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6411860" y="2498275"/>
            <a:ext cx="11520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Clostridium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0" y="2158952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sp>
        <p:nvSpPr>
          <p:cNvPr id="215" name="TextBox 214"/>
          <p:cNvSpPr txBox="1"/>
          <p:nvPr/>
        </p:nvSpPr>
        <p:spPr>
          <a:xfrm>
            <a:off x="3905556" y="215353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d)</a:t>
            </a:r>
          </a:p>
        </p:txBody>
      </p:sp>
      <p:sp>
        <p:nvSpPr>
          <p:cNvPr id="219" name="TextBox 218"/>
          <p:cNvSpPr txBox="1"/>
          <p:nvPr/>
        </p:nvSpPr>
        <p:spPr>
          <a:xfrm>
            <a:off x="969021" y="4543118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endParaRPr lang="en-US" sz="1600" b="1" i="1" dirty="0"/>
          </a:p>
        </p:txBody>
      </p:sp>
      <p:sp>
        <p:nvSpPr>
          <p:cNvPr id="220" name="TextBox 219"/>
          <p:cNvSpPr txBox="1"/>
          <p:nvPr/>
        </p:nvSpPr>
        <p:spPr>
          <a:xfrm>
            <a:off x="0" y="4162176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e)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3902210" y="4162176"/>
            <a:ext cx="406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f)</a:t>
            </a:r>
          </a:p>
        </p:txBody>
      </p:sp>
      <p:sp>
        <p:nvSpPr>
          <p:cNvPr id="249" name="TextBox 248"/>
          <p:cNvSpPr txBox="1"/>
          <p:nvPr/>
        </p:nvSpPr>
        <p:spPr>
          <a:xfrm>
            <a:off x="6411860" y="4631070"/>
            <a:ext cx="1307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Epulopiscium</a:t>
            </a:r>
            <a:endParaRPr lang="en-US" sz="1600" b="1" i="1" dirty="0"/>
          </a:p>
        </p:txBody>
      </p:sp>
      <p:sp>
        <p:nvSpPr>
          <p:cNvPr id="223" name="TextBox 222"/>
          <p:cNvSpPr txBox="1"/>
          <p:nvPr/>
        </p:nvSpPr>
        <p:spPr>
          <a:xfrm>
            <a:off x="650532" y="6556555"/>
            <a:ext cx="15253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[</a:t>
            </a:r>
            <a:r>
              <a:rPr lang="en-US" sz="1600" b="1" i="1" dirty="0" err="1"/>
              <a:t>Ruminococcus</a:t>
            </a:r>
            <a:r>
              <a:rPr lang="en-US" sz="1600" b="1" i="1" dirty="0"/>
              <a:t>]</a:t>
            </a:r>
          </a:p>
        </p:txBody>
      </p:sp>
      <p:sp>
        <p:nvSpPr>
          <p:cNvPr id="226" name="TextBox 225"/>
          <p:cNvSpPr txBox="1"/>
          <p:nvPr/>
        </p:nvSpPr>
        <p:spPr>
          <a:xfrm>
            <a:off x="-898" y="617123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g)</a:t>
            </a:r>
          </a:p>
        </p:txBody>
      </p:sp>
      <p:sp>
        <p:nvSpPr>
          <p:cNvPr id="227" name="TextBox 226"/>
          <p:cNvSpPr txBox="1"/>
          <p:nvPr/>
        </p:nvSpPr>
        <p:spPr>
          <a:xfrm>
            <a:off x="3899747" y="617123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h )</a:t>
            </a:r>
          </a:p>
        </p:txBody>
      </p:sp>
      <p:sp>
        <p:nvSpPr>
          <p:cNvPr id="225" name="TextBox 224"/>
          <p:cNvSpPr txBox="1"/>
          <p:nvPr/>
        </p:nvSpPr>
        <p:spPr>
          <a:xfrm>
            <a:off x="5105200" y="6471217"/>
            <a:ext cx="14446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Anaerotruncus</a:t>
            </a:r>
            <a:endParaRPr lang="en-US" sz="1600" b="1" i="1" dirty="0"/>
          </a:p>
        </p:txBody>
      </p:sp>
      <p:sp>
        <p:nvSpPr>
          <p:cNvPr id="229" name="TextBox 228"/>
          <p:cNvSpPr txBox="1"/>
          <p:nvPr/>
        </p:nvSpPr>
        <p:spPr>
          <a:xfrm>
            <a:off x="1371385" y="8529478"/>
            <a:ext cx="1165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Oscillospira</a:t>
            </a:r>
            <a:endParaRPr lang="en-US" sz="1600" b="1" i="1" dirty="0"/>
          </a:p>
        </p:txBody>
      </p:sp>
      <p:sp>
        <p:nvSpPr>
          <p:cNvPr id="232" name="TextBox 231"/>
          <p:cNvSpPr txBox="1"/>
          <p:nvPr/>
        </p:nvSpPr>
        <p:spPr>
          <a:xfrm>
            <a:off x="-11531" y="8179299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</a:t>
            </a:r>
            <a:r>
              <a:rPr lang="en-US" b="1" dirty="0" err="1"/>
              <a:t>i</a:t>
            </a:r>
            <a:r>
              <a:rPr lang="en-US" b="1" dirty="0"/>
              <a:t>)</a:t>
            </a:r>
          </a:p>
        </p:txBody>
      </p:sp>
      <p:sp>
        <p:nvSpPr>
          <p:cNvPr id="233" name="TextBox 232"/>
          <p:cNvSpPr txBox="1"/>
          <p:nvPr/>
        </p:nvSpPr>
        <p:spPr>
          <a:xfrm>
            <a:off x="3921012" y="8179299"/>
            <a:ext cx="446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j )</a:t>
            </a:r>
          </a:p>
        </p:txBody>
      </p:sp>
      <p:sp>
        <p:nvSpPr>
          <p:cNvPr id="231" name="TextBox 230"/>
          <p:cNvSpPr txBox="1"/>
          <p:nvPr/>
        </p:nvSpPr>
        <p:spPr>
          <a:xfrm>
            <a:off x="5168569" y="8531001"/>
            <a:ext cx="1390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Ruminococcus</a:t>
            </a:r>
            <a:endParaRPr lang="en-US" sz="1600" b="1" i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12001" y="10262449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k)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1106629" y="10599236"/>
            <a:ext cx="1330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Coprobacillus</a:t>
            </a:r>
            <a:endParaRPr lang="en-US" sz="1600" b="1" i="1" dirty="0"/>
          </a:p>
        </p:txBody>
      </p:sp>
      <p:sp>
        <p:nvSpPr>
          <p:cNvPr id="256" name="TextBox 255"/>
          <p:cNvSpPr txBox="1"/>
          <p:nvPr/>
        </p:nvSpPr>
        <p:spPr>
          <a:xfrm>
            <a:off x="3909860" y="10262449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l)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6063026" y="10590421"/>
            <a:ext cx="5116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LAR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27163" y="12945875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m)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3879880" y="1294587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n)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5073297" y="13096055"/>
            <a:ext cx="20783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Streptococcus </a:t>
            </a:r>
            <a:r>
              <a:rPr lang="en-US" sz="1600" b="1" i="1" dirty="0" err="1"/>
              <a:t>luteciae</a:t>
            </a:r>
            <a:endParaRPr lang="en-US" sz="1600" b="1" i="1" dirty="0"/>
          </a:p>
        </p:txBody>
      </p:sp>
      <p:sp>
        <p:nvSpPr>
          <p:cNvPr id="212" name="TextBox 211"/>
          <p:cNvSpPr txBox="1"/>
          <p:nvPr/>
        </p:nvSpPr>
        <p:spPr>
          <a:xfrm>
            <a:off x="1312456" y="13100143"/>
            <a:ext cx="1207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Unclassified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27163" y="15207716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o)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3909860" y="15207716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p)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1245180" y="15577048"/>
            <a:ext cx="22773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Clostridium </a:t>
            </a:r>
            <a:r>
              <a:rPr lang="en-US" sz="1600" b="1" i="1" dirty="0" err="1"/>
              <a:t>perfringenes</a:t>
            </a:r>
            <a:endParaRPr lang="en-US" sz="1600" b="1" i="1" dirty="0"/>
          </a:p>
        </p:txBody>
      </p:sp>
      <p:sp>
        <p:nvSpPr>
          <p:cNvPr id="210" name="TextBox 209"/>
          <p:cNvSpPr txBox="1"/>
          <p:nvPr/>
        </p:nvSpPr>
        <p:spPr>
          <a:xfrm>
            <a:off x="5020657" y="15642541"/>
            <a:ext cx="16137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/>
              <a:t>Blautia</a:t>
            </a:r>
            <a:r>
              <a:rPr lang="en-US" sz="1600" b="1" i="1" dirty="0"/>
              <a:t> </a:t>
            </a:r>
            <a:r>
              <a:rPr lang="en-US" sz="1600" b="1" i="1" dirty="0" err="1"/>
              <a:t>producta</a:t>
            </a:r>
            <a:endParaRPr lang="en-US" sz="1600" b="1" i="1" dirty="0"/>
          </a:p>
        </p:txBody>
      </p:sp>
    </p:spTree>
    <p:extLst>
      <p:ext uri="{BB962C8B-B14F-4D97-AF65-F5344CB8AC3E}">
        <p14:creationId xmlns:p14="http://schemas.microsoft.com/office/powerpoint/2010/main" val="4033629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65</TotalTime>
  <Words>74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glarz, Monika - ARS</dc:creator>
  <cp:lastModifiedBy>Weglarz, Monika - ARS</cp:lastModifiedBy>
  <cp:revision>37</cp:revision>
  <dcterms:created xsi:type="dcterms:W3CDTF">2020-11-23T13:57:10Z</dcterms:created>
  <dcterms:modified xsi:type="dcterms:W3CDTF">2022-05-18T11:56:55Z</dcterms:modified>
</cp:coreProperties>
</file>